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339" r:id="rId5"/>
    <p:sldId id="338" r:id="rId6"/>
  </p:sldIdLst>
  <p:sldSz cx="6858000" cy="9906000" type="A4"/>
  <p:notesSz cx="6858000" cy="9144000"/>
  <p:defaultTextStyle>
    <a:defPPr>
      <a:defRPr lang="en-US"/>
    </a:defPPr>
    <a:lvl1pPr marL="0" algn="l" defTabSz="872690" rtl="0" eaLnBrk="1" latinLnBrk="0" hangingPunct="1">
      <a:defRPr sz="1718" kern="1200">
        <a:solidFill>
          <a:schemeClr val="tx1"/>
        </a:solidFill>
        <a:latin typeface="+mn-lt"/>
        <a:ea typeface="+mn-ea"/>
        <a:cs typeface="+mn-cs"/>
      </a:defRPr>
    </a:lvl1pPr>
    <a:lvl2pPr marL="436345" algn="l" defTabSz="872690" rtl="0" eaLnBrk="1" latinLnBrk="0" hangingPunct="1">
      <a:defRPr sz="1718" kern="1200">
        <a:solidFill>
          <a:schemeClr val="tx1"/>
        </a:solidFill>
        <a:latin typeface="+mn-lt"/>
        <a:ea typeface="+mn-ea"/>
        <a:cs typeface="+mn-cs"/>
      </a:defRPr>
    </a:lvl2pPr>
    <a:lvl3pPr marL="872690" algn="l" defTabSz="872690" rtl="0" eaLnBrk="1" latinLnBrk="0" hangingPunct="1">
      <a:defRPr sz="1718" kern="1200">
        <a:solidFill>
          <a:schemeClr val="tx1"/>
        </a:solidFill>
        <a:latin typeface="+mn-lt"/>
        <a:ea typeface="+mn-ea"/>
        <a:cs typeface="+mn-cs"/>
      </a:defRPr>
    </a:lvl3pPr>
    <a:lvl4pPr marL="1309035" algn="l" defTabSz="872690" rtl="0" eaLnBrk="1" latinLnBrk="0" hangingPunct="1">
      <a:defRPr sz="1718" kern="1200">
        <a:solidFill>
          <a:schemeClr val="tx1"/>
        </a:solidFill>
        <a:latin typeface="+mn-lt"/>
        <a:ea typeface="+mn-ea"/>
        <a:cs typeface="+mn-cs"/>
      </a:defRPr>
    </a:lvl4pPr>
    <a:lvl5pPr marL="1745380" algn="l" defTabSz="872690" rtl="0" eaLnBrk="1" latinLnBrk="0" hangingPunct="1">
      <a:defRPr sz="1718" kern="1200">
        <a:solidFill>
          <a:schemeClr val="tx1"/>
        </a:solidFill>
        <a:latin typeface="+mn-lt"/>
        <a:ea typeface="+mn-ea"/>
        <a:cs typeface="+mn-cs"/>
      </a:defRPr>
    </a:lvl5pPr>
    <a:lvl6pPr marL="2181725" algn="l" defTabSz="872690" rtl="0" eaLnBrk="1" latinLnBrk="0" hangingPunct="1">
      <a:defRPr sz="1718" kern="1200">
        <a:solidFill>
          <a:schemeClr val="tx1"/>
        </a:solidFill>
        <a:latin typeface="+mn-lt"/>
        <a:ea typeface="+mn-ea"/>
        <a:cs typeface="+mn-cs"/>
      </a:defRPr>
    </a:lvl6pPr>
    <a:lvl7pPr marL="2618070" algn="l" defTabSz="872690" rtl="0" eaLnBrk="1" latinLnBrk="0" hangingPunct="1">
      <a:defRPr sz="1718" kern="1200">
        <a:solidFill>
          <a:schemeClr val="tx1"/>
        </a:solidFill>
        <a:latin typeface="+mn-lt"/>
        <a:ea typeface="+mn-ea"/>
        <a:cs typeface="+mn-cs"/>
      </a:defRPr>
    </a:lvl7pPr>
    <a:lvl8pPr marL="3054416" algn="l" defTabSz="872690" rtl="0" eaLnBrk="1" latinLnBrk="0" hangingPunct="1">
      <a:defRPr sz="1718" kern="1200">
        <a:solidFill>
          <a:schemeClr val="tx1"/>
        </a:solidFill>
        <a:latin typeface="+mn-lt"/>
        <a:ea typeface="+mn-ea"/>
        <a:cs typeface="+mn-cs"/>
      </a:defRPr>
    </a:lvl8pPr>
    <a:lvl9pPr marL="3490760" algn="l" defTabSz="872690" rtl="0" eaLnBrk="1" latinLnBrk="0" hangingPunct="1">
      <a:defRPr sz="1718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rvathy  Harikumar" initials="PH" lastIdx="2" clrIdx="0">
    <p:extLst>
      <p:ext uri="{19B8F6BF-5375-455C-9EA6-DF929625EA0E}">
        <p15:presenceInfo xmlns:p15="http://schemas.microsoft.com/office/powerpoint/2012/main" userId="S::Parvathy.Harikumar@nibsc.org::58811d80-9869-45d1-a9fb-2be9b3ec8b2e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8955" autoAdjust="0"/>
    <p:restoredTop sz="94641" autoAdjust="0"/>
  </p:normalViewPr>
  <p:slideViewPr>
    <p:cSldViewPr snapToGrid="0">
      <p:cViewPr varScale="1">
        <p:scale>
          <a:sx n="83" d="100"/>
          <a:sy n="83" d="100"/>
        </p:scale>
        <p:origin x="3331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621194"/>
            <a:ext cx="5143500" cy="3448756"/>
          </a:xfrm>
        </p:spPr>
        <p:txBody>
          <a:bodyPr anchor="b"/>
          <a:lstStyle>
            <a:lvl1pPr algn="ctr">
              <a:defRPr sz="2612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045"/>
            </a:lvl1pPr>
            <a:lvl2pPr marL="199016" indent="0" algn="ctr">
              <a:buNone/>
              <a:defRPr sz="871"/>
            </a:lvl2pPr>
            <a:lvl3pPr marL="398033" indent="0" algn="ctr">
              <a:buNone/>
              <a:defRPr sz="783"/>
            </a:lvl3pPr>
            <a:lvl4pPr marL="597049" indent="0" algn="ctr">
              <a:buNone/>
              <a:defRPr sz="699"/>
            </a:lvl4pPr>
            <a:lvl5pPr marL="796068" indent="0" algn="ctr">
              <a:buNone/>
              <a:defRPr sz="699"/>
            </a:lvl5pPr>
            <a:lvl6pPr marL="995085" indent="0" algn="ctr">
              <a:buNone/>
              <a:defRPr sz="699"/>
            </a:lvl6pPr>
            <a:lvl7pPr marL="1194101" indent="0" algn="ctr">
              <a:buNone/>
              <a:defRPr sz="699"/>
            </a:lvl7pPr>
            <a:lvl8pPr marL="1393117" indent="0" algn="ctr">
              <a:buNone/>
              <a:defRPr sz="699"/>
            </a:lvl8pPr>
            <a:lvl9pPr marL="1592134" indent="0" algn="ctr">
              <a:buNone/>
              <a:defRPr sz="699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29/06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67962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29/06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73783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527406"/>
            <a:ext cx="1478755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6"/>
            <a:ext cx="4350545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29/06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24667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29/06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037212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8"/>
            <a:ext cx="5915025" cy="4120620"/>
          </a:xfrm>
        </p:spPr>
        <p:txBody>
          <a:bodyPr anchor="b"/>
          <a:lstStyle>
            <a:lvl1pPr>
              <a:defRPr sz="2612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9"/>
            <a:ext cx="5915025" cy="2166936"/>
          </a:xfrm>
        </p:spPr>
        <p:txBody>
          <a:bodyPr/>
          <a:lstStyle>
            <a:lvl1pPr marL="0" indent="0">
              <a:buNone/>
              <a:defRPr sz="1045">
                <a:solidFill>
                  <a:schemeClr val="tx1">
                    <a:tint val="75000"/>
                  </a:schemeClr>
                </a:solidFill>
              </a:defRPr>
            </a:lvl1pPr>
            <a:lvl2pPr marL="199016" indent="0">
              <a:buNone/>
              <a:defRPr sz="871">
                <a:solidFill>
                  <a:schemeClr val="tx1">
                    <a:tint val="75000"/>
                  </a:schemeClr>
                </a:solidFill>
              </a:defRPr>
            </a:lvl2pPr>
            <a:lvl3pPr marL="398033" indent="0">
              <a:buNone/>
              <a:defRPr sz="783">
                <a:solidFill>
                  <a:schemeClr val="tx1">
                    <a:tint val="75000"/>
                  </a:schemeClr>
                </a:solidFill>
              </a:defRPr>
            </a:lvl3pPr>
            <a:lvl4pPr marL="597049" indent="0">
              <a:buNone/>
              <a:defRPr sz="699">
                <a:solidFill>
                  <a:schemeClr val="tx1">
                    <a:tint val="75000"/>
                  </a:schemeClr>
                </a:solidFill>
              </a:defRPr>
            </a:lvl4pPr>
            <a:lvl5pPr marL="796068" indent="0">
              <a:buNone/>
              <a:defRPr sz="699">
                <a:solidFill>
                  <a:schemeClr val="tx1">
                    <a:tint val="75000"/>
                  </a:schemeClr>
                </a:solidFill>
              </a:defRPr>
            </a:lvl5pPr>
            <a:lvl6pPr marL="995085" indent="0">
              <a:buNone/>
              <a:defRPr sz="699">
                <a:solidFill>
                  <a:schemeClr val="tx1">
                    <a:tint val="75000"/>
                  </a:schemeClr>
                </a:solidFill>
              </a:defRPr>
            </a:lvl6pPr>
            <a:lvl7pPr marL="1194101" indent="0">
              <a:buNone/>
              <a:defRPr sz="699">
                <a:solidFill>
                  <a:schemeClr val="tx1">
                    <a:tint val="75000"/>
                  </a:schemeClr>
                </a:solidFill>
              </a:defRPr>
            </a:lvl7pPr>
            <a:lvl8pPr marL="1393117" indent="0">
              <a:buNone/>
              <a:defRPr sz="699">
                <a:solidFill>
                  <a:schemeClr val="tx1">
                    <a:tint val="75000"/>
                  </a:schemeClr>
                </a:solidFill>
              </a:defRPr>
            </a:lvl8pPr>
            <a:lvl9pPr marL="1592134" indent="0">
              <a:buNone/>
              <a:defRPr sz="69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29/06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821138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29/06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10372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8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4" y="2428352"/>
            <a:ext cx="2901255" cy="1190095"/>
          </a:xfrm>
        </p:spPr>
        <p:txBody>
          <a:bodyPr anchor="b"/>
          <a:lstStyle>
            <a:lvl1pPr marL="0" indent="0">
              <a:buNone/>
              <a:defRPr sz="1045" b="1"/>
            </a:lvl1pPr>
            <a:lvl2pPr marL="199016" indent="0">
              <a:buNone/>
              <a:defRPr sz="871" b="1"/>
            </a:lvl2pPr>
            <a:lvl3pPr marL="398033" indent="0">
              <a:buNone/>
              <a:defRPr sz="783" b="1"/>
            </a:lvl3pPr>
            <a:lvl4pPr marL="597049" indent="0">
              <a:buNone/>
              <a:defRPr sz="699" b="1"/>
            </a:lvl4pPr>
            <a:lvl5pPr marL="796068" indent="0">
              <a:buNone/>
              <a:defRPr sz="699" b="1"/>
            </a:lvl5pPr>
            <a:lvl6pPr marL="995085" indent="0">
              <a:buNone/>
              <a:defRPr sz="699" b="1"/>
            </a:lvl6pPr>
            <a:lvl7pPr marL="1194101" indent="0">
              <a:buNone/>
              <a:defRPr sz="699" b="1"/>
            </a:lvl7pPr>
            <a:lvl8pPr marL="1393117" indent="0">
              <a:buNone/>
              <a:defRPr sz="699" b="1"/>
            </a:lvl8pPr>
            <a:lvl9pPr marL="1592134" indent="0">
              <a:buNone/>
              <a:defRPr sz="69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4" y="3618444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6" y="2428352"/>
            <a:ext cx="2915543" cy="1190095"/>
          </a:xfrm>
        </p:spPr>
        <p:txBody>
          <a:bodyPr anchor="b"/>
          <a:lstStyle>
            <a:lvl1pPr marL="0" indent="0">
              <a:buNone/>
              <a:defRPr sz="1045" b="1"/>
            </a:lvl1pPr>
            <a:lvl2pPr marL="199016" indent="0">
              <a:buNone/>
              <a:defRPr sz="871" b="1"/>
            </a:lvl2pPr>
            <a:lvl3pPr marL="398033" indent="0">
              <a:buNone/>
              <a:defRPr sz="783" b="1"/>
            </a:lvl3pPr>
            <a:lvl4pPr marL="597049" indent="0">
              <a:buNone/>
              <a:defRPr sz="699" b="1"/>
            </a:lvl4pPr>
            <a:lvl5pPr marL="796068" indent="0">
              <a:buNone/>
              <a:defRPr sz="699" b="1"/>
            </a:lvl5pPr>
            <a:lvl6pPr marL="995085" indent="0">
              <a:buNone/>
              <a:defRPr sz="699" b="1"/>
            </a:lvl6pPr>
            <a:lvl7pPr marL="1194101" indent="0">
              <a:buNone/>
              <a:defRPr sz="699" b="1"/>
            </a:lvl7pPr>
            <a:lvl8pPr marL="1393117" indent="0">
              <a:buNone/>
              <a:defRPr sz="699" b="1"/>
            </a:lvl8pPr>
            <a:lvl9pPr marL="1592134" indent="0">
              <a:buNone/>
              <a:defRPr sz="69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6" y="3618444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29/06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57471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29/06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89904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29/06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804124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1392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6" y="1426287"/>
            <a:ext cx="3471863" cy="7039681"/>
          </a:xfrm>
        </p:spPr>
        <p:txBody>
          <a:bodyPr/>
          <a:lstStyle>
            <a:lvl1pPr>
              <a:defRPr sz="1392"/>
            </a:lvl1pPr>
            <a:lvl2pPr>
              <a:defRPr sz="1220"/>
            </a:lvl2pPr>
            <a:lvl3pPr>
              <a:defRPr sz="1045"/>
            </a:lvl3pPr>
            <a:lvl4pPr>
              <a:defRPr sz="871"/>
            </a:lvl4pPr>
            <a:lvl5pPr>
              <a:defRPr sz="871"/>
            </a:lvl5pPr>
            <a:lvl6pPr>
              <a:defRPr sz="871"/>
            </a:lvl6pPr>
            <a:lvl7pPr>
              <a:defRPr sz="871"/>
            </a:lvl7pPr>
            <a:lvl8pPr>
              <a:defRPr sz="871"/>
            </a:lvl8pPr>
            <a:lvl9pPr>
              <a:defRPr sz="87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5"/>
            <a:ext cx="2211884" cy="5505627"/>
          </a:xfrm>
        </p:spPr>
        <p:txBody>
          <a:bodyPr/>
          <a:lstStyle>
            <a:lvl1pPr marL="0" indent="0">
              <a:buNone/>
              <a:defRPr sz="699"/>
            </a:lvl1pPr>
            <a:lvl2pPr marL="199016" indent="0">
              <a:buNone/>
              <a:defRPr sz="611"/>
            </a:lvl2pPr>
            <a:lvl3pPr marL="398033" indent="0">
              <a:buNone/>
              <a:defRPr sz="521"/>
            </a:lvl3pPr>
            <a:lvl4pPr marL="597049" indent="0">
              <a:buNone/>
              <a:defRPr sz="437"/>
            </a:lvl4pPr>
            <a:lvl5pPr marL="796068" indent="0">
              <a:buNone/>
              <a:defRPr sz="437"/>
            </a:lvl5pPr>
            <a:lvl6pPr marL="995085" indent="0">
              <a:buNone/>
              <a:defRPr sz="437"/>
            </a:lvl6pPr>
            <a:lvl7pPr marL="1194101" indent="0">
              <a:buNone/>
              <a:defRPr sz="437"/>
            </a:lvl7pPr>
            <a:lvl8pPr marL="1393117" indent="0">
              <a:buNone/>
              <a:defRPr sz="437"/>
            </a:lvl8pPr>
            <a:lvl9pPr marL="1592134" indent="0">
              <a:buNone/>
              <a:defRPr sz="43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29/06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81262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1392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6" y="1426287"/>
            <a:ext cx="3471863" cy="7039681"/>
          </a:xfrm>
        </p:spPr>
        <p:txBody>
          <a:bodyPr/>
          <a:lstStyle>
            <a:lvl1pPr marL="0" indent="0">
              <a:buNone/>
              <a:defRPr sz="1392"/>
            </a:lvl1pPr>
            <a:lvl2pPr marL="199016" indent="0">
              <a:buNone/>
              <a:defRPr sz="1220"/>
            </a:lvl2pPr>
            <a:lvl3pPr marL="398033" indent="0">
              <a:buNone/>
              <a:defRPr sz="1045"/>
            </a:lvl3pPr>
            <a:lvl4pPr marL="597049" indent="0">
              <a:buNone/>
              <a:defRPr sz="871"/>
            </a:lvl4pPr>
            <a:lvl5pPr marL="796068" indent="0">
              <a:buNone/>
              <a:defRPr sz="871"/>
            </a:lvl5pPr>
            <a:lvl6pPr marL="995085" indent="0">
              <a:buNone/>
              <a:defRPr sz="871"/>
            </a:lvl6pPr>
            <a:lvl7pPr marL="1194101" indent="0">
              <a:buNone/>
              <a:defRPr sz="871"/>
            </a:lvl7pPr>
            <a:lvl8pPr marL="1393117" indent="0">
              <a:buNone/>
              <a:defRPr sz="871"/>
            </a:lvl8pPr>
            <a:lvl9pPr marL="1592134" indent="0">
              <a:buNone/>
              <a:defRPr sz="871"/>
            </a:lvl9pPr>
          </a:lstStyle>
          <a:p>
            <a:r>
              <a:rPr lang="en-US" dirty="0"/>
              <a:t>Click icon to add picture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5"/>
            <a:ext cx="2211884" cy="5505627"/>
          </a:xfrm>
        </p:spPr>
        <p:txBody>
          <a:bodyPr/>
          <a:lstStyle>
            <a:lvl1pPr marL="0" indent="0">
              <a:buNone/>
              <a:defRPr sz="699"/>
            </a:lvl1pPr>
            <a:lvl2pPr marL="199016" indent="0">
              <a:buNone/>
              <a:defRPr sz="611"/>
            </a:lvl2pPr>
            <a:lvl3pPr marL="398033" indent="0">
              <a:buNone/>
              <a:defRPr sz="521"/>
            </a:lvl3pPr>
            <a:lvl4pPr marL="597049" indent="0">
              <a:buNone/>
              <a:defRPr sz="437"/>
            </a:lvl4pPr>
            <a:lvl5pPr marL="796068" indent="0">
              <a:buNone/>
              <a:defRPr sz="437"/>
            </a:lvl5pPr>
            <a:lvl6pPr marL="995085" indent="0">
              <a:buNone/>
              <a:defRPr sz="437"/>
            </a:lvl6pPr>
            <a:lvl7pPr marL="1194101" indent="0">
              <a:buNone/>
              <a:defRPr sz="437"/>
            </a:lvl7pPr>
            <a:lvl8pPr marL="1393117" indent="0">
              <a:buNone/>
              <a:defRPr sz="437"/>
            </a:lvl8pPr>
            <a:lvl9pPr marL="1592134" indent="0">
              <a:buNone/>
              <a:defRPr sz="43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D5C50-A4F9-4A1F-BD14-862065C97CA3}" type="datetimeFigureOut">
              <a:rPr lang="en-GB" smtClean="0"/>
              <a:t>29/06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07332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527408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1D5C50-A4F9-4A1F-BD14-862065C97CA3}" type="datetimeFigureOut">
              <a:rPr lang="en-GB" smtClean="0"/>
              <a:t>29/06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9181398"/>
            <a:ext cx="2314575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796753-6EDA-447F-AB54-31E6CCDD5AB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824063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398033" rtl="0" eaLnBrk="1" latinLnBrk="0" hangingPunct="1">
        <a:lnSpc>
          <a:spcPct val="90000"/>
        </a:lnSpc>
        <a:spcBef>
          <a:spcPct val="0"/>
        </a:spcBef>
        <a:buNone/>
        <a:defRPr sz="191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9510" indent="-99510" algn="l" defTabSz="398033" rtl="0" eaLnBrk="1" latinLnBrk="0" hangingPunct="1">
        <a:lnSpc>
          <a:spcPct val="90000"/>
        </a:lnSpc>
        <a:spcBef>
          <a:spcPts val="437"/>
        </a:spcBef>
        <a:buFont typeface="Arial" panose="020B0604020202020204" pitchFamily="34" charset="0"/>
        <a:buChar char="•"/>
        <a:defRPr sz="1220" kern="1200">
          <a:solidFill>
            <a:schemeClr val="tx1"/>
          </a:solidFill>
          <a:latin typeface="+mn-lt"/>
          <a:ea typeface="+mn-ea"/>
          <a:cs typeface="+mn-cs"/>
        </a:defRPr>
      </a:lvl1pPr>
      <a:lvl2pPr marL="298526" indent="-99510" algn="l" defTabSz="398033" rtl="0" eaLnBrk="1" latinLnBrk="0" hangingPunct="1">
        <a:lnSpc>
          <a:spcPct val="90000"/>
        </a:lnSpc>
        <a:spcBef>
          <a:spcPts val="218"/>
        </a:spcBef>
        <a:buFont typeface="Arial" panose="020B0604020202020204" pitchFamily="34" charset="0"/>
        <a:buChar char="•"/>
        <a:defRPr sz="1045" kern="1200">
          <a:solidFill>
            <a:schemeClr val="tx1"/>
          </a:solidFill>
          <a:latin typeface="+mn-lt"/>
          <a:ea typeface="+mn-ea"/>
          <a:cs typeface="+mn-cs"/>
        </a:defRPr>
      </a:lvl2pPr>
      <a:lvl3pPr marL="497542" indent="-99510" algn="l" defTabSz="398033" rtl="0" eaLnBrk="1" latinLnBrk="0" hangingPunct="1">
        <a:lnSpc>
          <a:spcPct val="90000"/>
        </a:lnSpc>
        <a:spcBef>
          <a:spcPts val="218"/>
        </a:spcBef>
        <a:buFont typeface="Arial" panose="020B0604020202020204" pitchFamily="34" charset="0"/>
        <a:buChar char="•"/>
        <a:defRPr sz="871" kern="1200">
          <a:solidFill>
            <a:schemeClr val="tx1"/>
          </a:solidFill>
          <a:latin typeface="+mn-lt"/>
          <a:ea typeface="+mn-ea"/>
          <a:cs typeface="+mn-cs"/>
        </a:defRPr>
      </a:lvl3pPr>
      <a:lvl4pPr marL="696559" indent="-99510" algn="l" defTabSz="398033" rtl="0" eaLnBrk="1" latinLnBrk="0" hangingPunct="1">
        <a:lnSpc>
          <a:spcPct val="90000"/>
        </a:lnSpc>
        <a:spcBef>
          <a:spcPts val="218"/>
        </a:spcBef>
        <a:buFont typeface="Arial" panose="020B0604020202020204" pitchFamily="34" charset="0"/>
        <a:buChar char="•"/>
        <a:defRPr sz="783" kern="1200">
          <a:solidFill>
            <a:schemeClr val="tx1"/>
          </a:solidFill>
          <a:latin typeface="+mn-lt"/>
          <a:ea typeface="+mn-ea"/>
          <a:cs typeface="+mn-cs"/>
        </a:defRPr>
      </a:lvl4pPr>
      <a:lvl5pPr marL="895575" indent="-99510" algn="l" defTabSz="398033" rtl="0" eaLnBrk="1" latinLnBrk="0" hangingPunct="1">
        <a:lnSpc>
          <a:spcPct val="90000"/>
        </a:lnSpc>
        <a:spcBef>
          <a:spcPts val="218"/>
        </a:spcBef>
        <a:buFont typeface="Arial" panose="020B0604020202020204" pitchFamily="34" charset="0"/>
        <a:buChar char="•"/>
        <a:defRPr sz="783" kern="1200">
          <a:solidFill>
            <a:schemeClr val="tx1"/>
          </a:solidFill>
          <a:latin typeface="+mn-lt"/>
          <a:ea typeface="+mn-ea"/>
          <a:cs typeface="+mn-cs"/>
        </a:defRPr>
      </a:lvl5pPr>
      <a:lvl6pPr marL="1094594" indent="-99510" algn="l" defTabSz="398033" rtl="0" eaLnBrk="1" latinLnBrk="0" hangingPunct="1">
        <a:lnSpc>
          <a:spcPct val="90000"/>
        </a:lnSpc>
        <a:spcBef>
          <a:spcPts val="218"/>
        </a:spcBef>
        <a:buFont typeface="Arial" panose="020B0604020202020204" pitchFamily="34" charset="0"/>
        <a:buChar char="•"/>
        <a:defRPr sz="783" kern="1200">
          <a:solidFill>
            <a:schemeClr val="tx1"/>
          </a:solidFill>
          <a:latin typeface="+mn-lt"/>
          <a:ea typeface="+mn-ea"/>
          <a:cs typeface="+mn-cs"/>
        </a:defRPr>
      </a:lvl6pPr>
      <a:lvl7pPr marL="1293611" indent="-99510" algn="l" defTabSz="398033" rtl="0" eaLnBrk="1" latinLnBrk="0" hangingPunct="1">
        <a:lnSpc>
          <a:spcPct val="90000"/>
        </a:lnSpc>
        <a:spcBef>
          <a:spcPts val="218"/>
        </a:spcBef>
        <a:buFont typeface="Arial" panose="020B0604020202020204" pitchFamily="34" charset="0"/>
        <a:buChar char="•"/>
        <a:defRPr sz="783" kern="1200">
          <a:solidFill>
            <a:schemeClr val="tx1"/>
          </a:solidFill>
          <a:latin typeface="+mn-lt"/>
          <a:ea typeface="+mn-ea"/>
          <a:cs typeface="+mn-cs"/>
        </a:defRPr>
      </a:lvl7pPr>
      <a:lvl8pPr marL="1492627" indent="-99510" algn="l" defTabSz="398033" rtl="0" eaLnBrk="1" latinLnBrk="0" hangingPunct="1">
        <a:lnSpc>
          <a:spcPct val="90000"/>
        </a:lnSpc>
        <a:spcBef>
          <a:spcPts val="218"/>
        </a:spcBef>
        <a:buFont typeface="Arial" panose="020B0604020202020204" pitchFamily="34" charset="0"/>
        <a:buChar char="•"/>
        <a:defRPr sz="783" kern="1200">
          <a:solidFill>
            <a:schemeClr val="tx1"/>
          </a:solidFill>
          <a:latin typeface="+mn-lt"/>
          <a:ea typeface="+mn-ea"/>
          <a:cs typeface="+mn-cs"/>
        </a:defRPr>
      </a:lvl8pPr>
      <a:lvl9pPr marL="1691643" indent="-99510" algn="l" defTabSz="398033" rtl="0" eaLnBrk="1" latinLnBrk="0" hangingPunct="1">
        <a:lnSpc>
          <a:spcPct val="90000"/>
        </a:lnSpc>
        <a:spcBef>
          <a:spcPts val="218"/>
        </a:spcBef>
        <a:buFont typeface="Arial" panose="020B0604020202020204" pitchFamily="34" charset="0"/>
        <a:buChar char="•"/>
        <a:defRPr sz="78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98033" rtl="0" eaLnBrk="1" latinLnBrk="0" hangingPunct="1">
        <a:defRPr sz="783" kern="1200">
          <a:solidFill>
            <a:schemeClr val="tx1"/>
          </a:solidFill>
          <a:latin typeface="+mn-lt"/>
          <a:ea typeface="+mn-ea"/>
          <a:cs typeface="+mn-cs"/>
        </a:defRPr>
      </a:lvl1pPr>
      <a:lvl2pPr marL="199016" algn="l" defTabSz="398033" rtl="0" eaLnBrk="1" latinLnBrk="0" hangingPunct="1">
        <a:defRPr sz="783" kern="1200">
          <a:solidFill>
            <a:schemeClr val="tx1"/>
          </a:solidFill>
          <a:latin typeface="+mn-lt"/>
          <a:ea typeface="+mn-ea"/>
          <a:cs typeface="+mn-cs"/>
        </a:defRPr>
      </a:lvl2pPr>
      <a:lvl3pPr marL="398033" algn="l" defTabSz="398033" rtl="0" eaLnBrk="1" latinLnBrk="0" hangingPunct="1">
        <a:defRPr sz="783" kern="1200">
          <a:solidFill>
            <a:schemeClr val="tx1"/>
          </a:solidFill>
          <a:latin typeface="+mn-lt"/>
          <a:ea typeface="+mn-ea"/>
          <a:cs typeface="+mn-cs"/>
        </a:defRPr>
      </a:lvl3pPr>
      <a:lvl4pPr marL="597049" algn="l" defTabSz="398033" rtl="0" eaLnBrk="1" latinLnBrk="0" hangingPunct="1">
        <a:defRPr sz="783" kern="1200">
          <a:solidFill>
            <a:schemeClr val="tx1"/>
          </a:solidFill>
          <a:latin typeface="+mn-lt"/>
          <a:ea typeface="+mn-ea"/>
          <a:cs typeface="+mn-cs"/>
        </a:defRPr>
      </a:lvl4pPr>
      <a:lvl5pPr marL="796068" algn="l" defTabSz="398033" rtl="0" eaLnBrk="1" latinLnBrk="0" hangingPunct="1">
        <a:defRPr sz="783" kern="1200">
          <a:solidFill>
            <a:schemeClr val="tx1"/>
          </a:solidFill>
          <a:latin typeface="+mn-lt"/>
          <a:ea typeface="+mn-ea"/>
          <a:cs typeface="+mn-cs"/>
        </a:defRPr>
      </a:lvl5pPr>
      <a:lvl6pPr marL="995085" algn="l" defTabSz="398033" rtl="0" eaLnBrk="1" latinLnBrk="0" hangingPunct="1">
        <a:defRPr sz="783" kern="1200">
          <a:solidFill>
            <a:schemeClr val="tx1"/>
          </a:solidFill>
          <a:latin typeface="+mn-lt"/>
          <a:ea typeface="+mn-ea"/>
          <a:cs typeface="+mn-cs"/>
        </a:defRPr>
      </a:lvl6pPr>
      <a:lvl7pPr marL="1194101" algn="l" defTabSz="398033" rtl="0" eaLnBrk="1" latinLnBrk="0" hangingPunct="1">
        <a:defRPr sz="783" kern="1200">
          <a:solidFill>
            <a:schemeClr val="tx1"/>
          </a:solidFill>
          <a:latin typeface="+mn-lt"/>
          <a:ea typeface="+mn-ea"/>
          <a:cs typeface="+mn-cs"/>
        </a:defRPr>
      </a:lvl7pPr>
      <a:lvl8pPr marL="1393117" algn="l" defTabSz="398033" rtl="0" eaLnBrk="1" latinLnBrk="0" hangingPunct="1">
        <a:defRPr sz="783" kern="1200">
          <a:solidFill>
            <a:schemeClr val="tx1"/>
          </a:solidFill>
          <a:latin typeface="+mn-lt"/>
          <a:ea typeface="+mn-ea"/>
          <a:cs typeface="+mn-cs"/>
        </a:defRPr>
      </a:lvl8pPr>
      <a:lvl9pPr marL="1592134" algn="l" defTabSz="398033" rtl="0" eaLnBrk="1" latinLnBrk="0" hangingPunct="1">
        <a:defRPr sz="78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CCA4B4FD-BC15-DA41-A820-2352B50935BA}"/>
              </a:ext>
            </a:extLst>
          </p:cNvPr>
          <p:cNvSpPr txBox="1"/>
          <p:nvPr/>
        </p:nvSpPr>
        <p:spPr>
          <a:xfrm>
            <a:off x="148590" y="4746207"/>
            <a:ext cx="6408327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/>
              <a:t>Supplementary Figure S1. </a:t>
            </a:r>
            <a:r>
              <a:rPr lang="en-GB" sz="1100" dirty="0"/>
              <a:t>Representative flow cytometry plots displaying gating strategies to assess T cell activation. Lymphocytes were first gated on FSC/SSC and then doublets were discriminated using FSC-H/FSC-A single cells gate. Live cells were gated as negative population for Aqua dead stain and T cells were gated as CD3-Pacific Blue population.CD8+ cytotoxic T cells and CD4+ T helper cells were then gated on single/live CD3+ T cells. CD3+ live single cells, CD4+CD3+ live single cells and CD8+CD3+ live single cells were analysed using two different panels: for CD49d (VLA-4 subunit)-PE+ and LFA-1-AF647+ or CD25-PE+ and CD69-PE-Cy7+ activation markers. Isotype controls and FMOs were used as experimental and gating controls. Results were presented as Median Fluorescence Intensity of pan, CD4+ or CD8+ T cells using the above gating strategy. </a:t>
            </a:r>
          </a:p>
          <a:p>
            <a:pPr algn="just"/>
            <a:endParaRPr lang="en-GB" sz="1100" dirty="0"/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BBAF663E-CEAB-10E0-63C9-07F04D4412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6478" y="1382177"/>
            <a:ext cx="6300439" cy="27703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27656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11C22FE-4EAB-5147-63CF-ABD09F825744}"/>
              </a:ext>
            </a:extLst>
          </p:cNvPr>
          <p:cNvSpPr txBox="1"/>
          <p:nvPr/>
        </p:nvSpPr>
        <p:spPr>
          <a:xfrm>
            <a:off x="101473" y="4656436"/>
            <a:ext cx="6645014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/>
              <a:t>Supplementary Figure S2. </a:t>
            </a:r>
            <a:r>
              <a:rPr lang="en-GB" sz="1100" dirty="0"/>
              <a:t>Representative flow cytometry plots displaying gating strategies to assess T cell proliferative responses measured with the CFDA-SE dye dilution. Lymphocytes were first gated on FSC/SSC and then doublets were discriminated using FSC-H/FSC-A single cells gate. Live cells were gated as negative population for Far Red dead stain and T cells were gated as CD3-Pacific Blue popula-tion.CD8+ cytotoxic T cells and CD4+ T helper cells were then gated on single/live CD3+ T cells. CD3+ live single cells, CD4+CD3+ live single cells and CD8+CD3+ live single cells were analysed separately for CFDA-SE dye dilutions. Isotype controls and FMOs were used as experimental and gating controls. Proliferating cells are gated using unstimulated controls. Results were presented as % of proliferating cells using the above gating strategy.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4C96FC2-AE80-18B0-C081-908F97AA2C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473" y="916404"/>
            <a:ext cx="6645014" cy="32115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82981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Custom 1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esentation1" id="{09FD1574-6B76-478D-B748-39E12DFC4B80}" vid="{C2C441BF-D134-4CB8-9922-908F33263704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A80B22A7C471842A7E58BADDE5E7A4B" ma:contentTypeVersion="12" ma:contentTypeDescription="Create a new document." ma:contentTypeScope="" ma:versionID="a8922906f400981c30bd2b2c23dc7502">
  <xsd:schema xmlns:xsd="http://www.w3.org/2001/XMLSchema" xmlns:xs="http://www.w3.org/2001/XMLSchema" xmlns:p="http://schemas.microsoft.com/office/2006/metadata/properties" xmlns:ns3="82ae39a7-1d5a-4dd6-b249-0e57218a6f1e" xmlns:ns4="b447599a-0d05-4d9f-b452-27dc0079e13d" targetNamespace="http://schemas.microsoft.com/office/2006/metadata/properties" ma:root="true" ma:fieldsID="f72e49fa81869abe19777fc61a951712" ns3:_="" ns4:_="">
    <xsd:import namespace="82ae39a7-1d5a-4dd6-b249-0e57218a6f1e"/>
    <xsd:import namespace="b447599a-0d05-4d9f-b452-27dc0079e13d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DateTaken" minOccurs="0"/>
                <xsd:element ref="ns4:MediaServiceAutoTags" minOccurs="0"/>
                <xsd:element ref="ns4:MediaServiceGenerationTime" minOccurs="0"/>
                <xsd:element ref="ns4:MediaServiceEventHashCode" minOccurs="0"/>
                <xsd:element ref="ns4:MediaServiceOCR" minOccurs="0"/>
                <xsd:element ref="ns4:MediaServiceAutoKeyPoints" minOccurs="0"/>
                <xsd:element ref="ns4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2ae39a7-1d5a-4dd6-b249-0e57218a6f1e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447599a-0d05-4d9f-b452-27dc0079e13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162D5DDB-70A8-4BC7-8D97-DEA9CB9A4CDE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7D620F40-60E9-43D1-85CE-035C8AE20AC3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36FA4B3-C7F5-4DF8-A64D-90F3CB4AD70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2ae39a7-1d5a-4dd6-b249-0e57218a6f1e"/>
    <ds:schemaRef ds:uri="b447599a-0d05-4d9f-b452-27dc0079e13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9685</TotalTime>
  <Words>318</Words>
  <Application>Microsoft Office PowerPoint</Application>
  <PresentationFormat>A4 Paper (210x297 mm)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4" baseType="lpstr">
      <vt:lpstr>Arial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vathy  Harikumar</dc:creator>
  <cp:lastModifiedBy>MDPI</cp:lastModifiedBy>
  <cp:revision>144</cp:revision>
  <dcterms:created xsi:type="dcterms:W3CDTF">2020-11-26T13:26:21Z</dcterms:created>
  <dcterms:modified xsi:type="dcterms:W3CDTF">2025-06-29T05:20:07Z</dcterms:modified>
</cp:coreProperties>
</file>